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2" r:id="rId2"/>
    <p:sldId id="264" r:id="rId3"/>
  </p:sldIdLst>
  <p:sldSz cx="6858000" cy="9906000" type="A4"/>
  <p:notesSz cx="7099300" cy="102346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84" userDrawn="1">
          <p15:clr>
            <a:srgbClr val="A4A3A4"/>
          </p15:clr>
        </p15:guide>
        <p15:guide id="2" pos="210" userDrawn="1">
          <p15:clr>
            <a:srgbClr val="A4A3A4"/>
          </p15:clr>
        </p15:guide>
        <p15:guide id="3" orient="horz" pos="49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00FF"/>
    <a:srgbClr val="FF75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860" autoAdjust="0"/>
    <p:restoredTop sz="95535" autoAdjust="0"/>
  </p:normalViewPr>
  <p:slideViewPr>
    <p:cSldViewPr snapToGrid="0" showGuides="1">
      <p:cViewPr>
        <p:scale>
          <a:sx n="102" d="100"/>
          <a:sy n="102" d="100"/>
        </p:scale>
        <p:origin x="58" y="-154"/>
      </p:cViewPr>
      <p:guideLst>
        <p:guide orient="horz" pos="2984"/>
        <p:guide pos="210"/>
        <p:guide orient="horz" pos="49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G-PC\Desktop\20180620%20Tdenolase%20(revision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My%20folder\Data\RA\2012.12.16%20CAL%20&#49688;&#51221;%20&#54980;%20&#52572;&#51333;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5844191471173922"/>
          <c:y val="0.18278269314081519"/>
          <c:w val="0.68284412860433163"/>
          <c:h val="0.62170472970867419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1</c:f>
              <c:strCache>
                <c:ptCount val="1"/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C$2:$C$43</c:f>
              <c:numCache>
                <c:formatCode>General</c:formatCode>
                <c:ptCount val="42"/>
                <c:pt idx="0">
                  <c:v>28.512799199999993</c:v>
                </c:pt>
                <c:pt idx="1">
                  <c:v>54.610569108000007</c:v>
                </c:pt>
                <c:pt idx="2">
                  <c:v>17.481672911999997</c:v>
                </c:pt>
                <c:pt idx="3">
                  <c:v>38.227425825000005</c:v>
                </c:pt>
                <c:pt idx="4">
                  <c:v>55.181548257000003</c:v>
                </c:pt>
                <c:pt idx="5">
                  <c:v>22.344339824999995</c:v>
                </c:pt>
                <c:pt idx="6">
                  <c:v>10.760414576999997</c:v>
                </c:pt>
                <c:pt idx="7">
                  <c:v>39.531632800000004</c:v>
                </c:pt>
                <c:pt idx="8">
                  <c:v>10.6780216355</c:v>
                </c:pt>
                <c:pt idx="9">
                  <c:v>15.7892294875</c:v>
                </c:pt>
                <c:pt idx="10">
                  <c:v>18.739742911999997</c:v>
                </c:pt>
                <c:pt idx="11">
                  <c:v>9.6997189580000001</c:v>
                </c:pt>
                <c:pt idx="12">
                  <c:v>34.339366591999998</c:v>
                </c:pt>
                <c:pt idx="13">
                  <c:v>8.0328683554999998</c:v>
                </c:pt>
                <c:pt idx="14">
                  <c:v>7.3552915979999991</c:v>
                </c:pt>
                <c:pt idx="15">
                  <c:v>13.548048608000002</c:v>
                </c:pt>
                <c:pt idx="16">
                  <c:v>29.822605848000002</c:v>
                </c:pt>
                <c:pt idx="17">
                  <c:v>17.5602544875</c:v>
                </c:pt>
                <c:pt idx="18">
                  <c:v>22.002032379499994</c:v>
                </c:pt>
                <c:pt idx="19">
                  <c:v>44.084278887499991</c:v>
                </c:pt>
                <c:pt idx="20">
                  <c:v>80.094001976999991</c:v>
                </c:pt>
                <c:pt idx="21">
                  <c:v>43.867947776999998</c:v>
                </c:pt>
                <c:pt idx="22">
                  <c:v>29.045454431999996</c:v>
                </c:pt>
                <c:pt idx="23">
                  <c:v>13.117424336999999</c:v>
                </c:pt>
                <c:pt idx="24">
                  <c:v>29.683207424999992</c:v>
                </c:pt>
                <c:pt idx="25">
                  <c:v>47.182806632999991</c:v>
                </c:pt>
                <c:pt idx="26">
                  <c:v>29.179246799999998</c:v>
                </c:pt>
                <c:pt idx="27">
                  <c:v>31.285179347999996</c:v>
                </c:pt>
                <c:pt idx="28">
                  <c:v>26.0410199875</c:v>
                </c:pt>
                <c:pt idx="29">
                  <c:v>19.276474415499997</c:v>
                </c:pt>
                <c:pt idx="30">
                  <c:v>16.819748541999999</c:v>
                </c:pt>
                <c:pt idx="31">
                  <c:v>29.110678095500003</c:v>
                </c:pt>
                <c:pt idx="32">
                  <c:v>6.286392887499999</c:v>
                </c:pt>
                <c:pt idx="33">
                  <c:v>40.443452355499993</c:v>
                </c:pt>
                <c:pt idx="34">
                  <c:v>38.981387902000002</c:v>
                </c:pt>
                <c:pt idx="35">
                  <c:v>29.822605848000002</c:v>
                </c:pt>
                <c:pt idx="36">
                  <c:v>38.006496781999999</c:v>
                </c:pt>
                <c:pt idx="37">
                  <c:v>32.563500061999996</c:v>
                </c:pt>
                <c:pt idx="38">
                  <c:v>32.978967075500002</c:v>
                </c:pt>
                <c:pt idx="39">
                  <c:v>25.167172032000003</c:v>
                </c:pt>
                <c:pt idx="40">
                  <c:v>35.24288047200001</c:v>
                </c:pt>
                <c:pt idx="41">
                  <c:v>44.896952767999998</c:v>
                </c:pt>
              </c:numCache>
            </c:numRef>
          </c:xVal>
          <c:yVal>
            <c:numRef>
              <c:f>Sheet1!$B$2:$B$43</c:f>
              <c:numCache>
                <c:formatCode>General</c:formatCode>
                <c:ptCount val="42"/>
                <c:pt idx="0">
                  <c:v>93.850170530749978</c:v>
                </c:pt>
                <c:pt idx="1">
                  <c:v>137.37161231675</c:v>
                </c:pt>
                <c:pt idx="2">
                  <c:v>86.783924966749979</c:v>
                </c:pt>
                <c:pt idx="3">
                  <c:v>121.31269729075001</c:v>
                </c:pt>
                <c:pt idx="4">
                  <c:v>125.32956911674998</c:v>
                </c:pt>
                <c:pt idx="5">
                  <c:v>92.034333666999999</c:v>
                </c:pt>
                <c:pt idx="6">
                  <c:v>66.012988226750011</c:v>
                </c:pt>
                <c:pt idx="7">
                  <c:v>132.51692592500004</c:v>
                </c:pt>
                <c:pt idx="8">
                  <c:v>85.004957309249974</c:v>
                </c:pt>
                <c:pt idx="9">
                  <c:v>80.729804063249986</c:v>
                </c:pt>
                <c:pt idx="10">
                  <c:v>92.030183081249987</c:v>
                </c:pt>
                <c:pt idx="11">
                  <c:v>89.695556699249991</c:v>
                </c:pt>
                <c:pt idx="12">
                  <c:v>111.978778932</c:v>
                </c:pt>
                <c:pt idx="13">
                  <c:v>75.525357971999981</c:v>
                </c:pt>
                <c:pt idx="14">
                  <c:v>52.703406387999983</c:v>
                </c:pt>
                <c:pt idx="15">
                  <c:v>65.128707396999999</c:v>
                </c:pt>
                <c:pt idx="16">
                  <c:v>97.375967252999999</c:v>
                </c:pt>
                <c:pt idx="17">
                  <c:v>92.535401907999983</c:v>
                </c:pt>
                <c:pt idx="18">
                  <c:v>104.55512789925001</c:v>
                </c:pt>
                <c:pt idx="19">
                  <c:v>98.937783129250022</c:v>
                </c:pt>
                <c:pt idx="20">
                  <c:v>100.95094228674999</c:v>
                </c:pt>
                <c:pt idx="21">
                  <c:v>140.43119129199999</c:v>
                </c:pt>
                <c:pt idx="22">
                  <c:v>93.018077386750008</c:v>
                </c:pt>
                <c:pt idx="23">
                  <c:v>75.893924847999997</c:v>
                </c:pt>
                <c:pt idx="24">
                  <c:v>111.87479929674998</c:v>
                </c:pt>
                <c:pt idx="25">
                  <c:v>123.66820831075</c:v>
                </c:pt>
                <c:pt idx="26">
                  <c:v>100.84322699674999</c:v>
                </c:pt>
                <c:pt idx="27">
                  <c:v>111.59260740799998</c:v>
                </c:pt>
                <c:pt idx="28">
                  <c:v>105.86864621300002</c:v>
                </c:pt>
                <c:pt idx="29">
                  <c:v>107.35273717199999</c:v>
                </c:pt>
                <c:pt idx="30">
                  <c:v>101.19456485325</c:v>
                </c:pt>
                <c:pt idx="31">
                  <c:v>112.62189595325</c:v>
                </c:pt>
                <c:pt idx="32">
                  <c:v>95.691776803249994</c:v>
                </c:pt>
                <c:pt idx="33">
                  <c:v>97.382605533000003</c:v>
                </c:pt>
                <c:pt idx="34">
                  <c:v>121.68276058124998</c:v>
                </c:pt>
                <c:pt idx="35">
                  <c:v>78.429224169249977</c:v>
                </c:pt>
                <c:pt idx="36">
                  <c:v>111.33715566925</c:v>
                </c:pt>
                <c:pt idx="37">
                  <c:v>94.854795023250006</c:v>
                </c:pt>
                <c:pt idx="38">
                  <c:v>109.50772757199999</c:v>
                </c:pt>
                <c:pt idx="39">
                  <c:v>97.464932500000018</c:v>
                </c:pt>
                <c:pt idx="40">
                  <c:v>101.54893112325001</c:v>
                </c:pt>
                <c:pt idx="41">
                  <c:v>101.95668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359-4569-96AF-5406177859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2662527"/>
        <c:axId val="1912663775"/>
      </c:scatterChart>
      <c:valAx>
        <c:axId val="1912662527"/>
        <c:scaling>
          <c:orientation val="minMax"/>
          <c:max val="1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b="1"/>
                  <a:t>anti-TdEno Ab (</a:t>
                </a:r>
                <a:r>
                  <a:rPr lang="el-GR" b="1"/>
                  <a:t>μ</a:t>
                </a:r>
                <a:r>
                  <a:rPr lang="en-US" b="1"/>
                  <a:t>g/ml)</a:t>
                </a:r>
                <a:endParaRPr lang="ko-KR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1912663775"/>
        <c:crosses val="autoZero"/>
        <c:crossBetween val="midCat"/>
        <c:majorUnit val="25"/>
      </c:valAx>
      <c:valAx>
        <c:axId val="191266377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b="1"/>
                  <a:t>anti-ENO1 Ab (</a:t>
                </a:r>
                <a:r>
                  <a:rPr lang="el-GR" b="1"/>
                  <a:t>μ</a:t>
                </a:r>
                <a:r>
                  <a:rPr lang="en-US" b="1"/>
                  <a:t>g/ml)</a:t>
                </a:r>
                <a:endParaRPr lang="ko-KR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1912662527"/>
        <c:crosses val="autoZero"/>
        <c:crossBetween val="midCat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RA!$D$2:$D$81</c:f>
              <c:numCache>
                <c:formatCode>0</c:formatCode>
                <c:ptCount val="80"/>
                <c:pt idx="0">
                  <c:v>25.318507499999999</c:v>
                </c:pt>
                <c:pt idx="1">
                  <c:v>30.104084999999991</c:v>
                </c:pt>
                <c:pt idx="2">
                  <c:v>27.00357</c:v>
                </c:pt>
                <c:pt idx="3">
                  <c:v>23.736322500000004</c:v>
                </c:pt>
                <c:pt idx="4">
                  <c:v>34.616504999999997</c:v>
                </c:pt>
                <c:pt idx="5">
                  <c:v>17.0506107</c:v>
                </c:pt>
                <c:pt idx="6">
                  <c:v>58.511703300000001</c:v>
                </c:pt>
                <c:pt idx="7">
                  <c:v>37.213894200000006</c:v>
                </c:pt>
                <c:pt idx="8">
                  <c:v>31.344905999999995</c:v>
                </c:pt>
                <c:pt idx="9">
                  <c:v>27.592249049999999</c:v>
                </c:pt>
                <c:pt idx="10">
                  <c:v>27.892602750000005</c:v>
                </c:pt>
                <c:pt idx="11">
                  <c:v>27.687483149999998</c:v>
                </c:pt>
                <c:pt idx="12">
                  <c:v>10.995875700000001</c:v>
                </c:pt>
                <c:pt idx="13">
                  <c:v>67.074109199999995</c:v>
                </c:pt>
                <c:pt idx="14">
                  <c:v>25.923952799999995</c:v>
                </c:pt>
                <c:pt idx="15">
                  <c:v>15.165084600000002</c:v>
                </c:pt>
                <c:pt idx="16">
                  <c:v>38.272766399999995</c:v>
                </c:pt>
                <c:pt idx="17">
                  <c:v>34.854027299999998</c:v>
                </c:pt>
                <c:pt idx="18">
                  <c:v>35.463625200000003</c:v>
                </c:pt>
                <c:pt idx="19">
                  <c:v>27.789614999999991</c:v>
                </c:pt>
                <c:pt idx="20">
                  <c:v>26.787676499999996</c:v>
                </c:pt>
                <c:pt idx="21">
                  <c:v>35.430813899999997</c:v>
                </c:pt>
                <c:pt idx="22">
                  <c:v>36.062224200000003</c:v>
                </c:pt>
                <c:pt idx="23">
                  <c:v>53.911853099999995</c:v>
                </c:pt>
                <c:pt idx="24">
                  <c:v>42.924277500000009</c:v>
                </c:pt>
                <c:pt idx="25">
                  <c:v>32.451798599999996</c:v>
                </c:pt>
                <c:pt idx="26">
                  <c:v>19.318536899999998</c:v>
                </c:pt>
                <c:pt idx="27">
                  <c:v>15.807975300000003</c:v>
                </c:pt>
                <c:pt idx="28">
                  <c:v>33.963290399999991</c:v>
                </c:pt>
                <c:pt idx="29">
                  <c:v>12.716852849999995</c:v>
                </c:pt>
                <c:pt idx="30">
                  <c:v>52.967506799999995</c:v>
                </c:pt>
                <c:pt idx="31">
                  <c:v>11.857082249999998</c:v>
                </c:pt>
                <c:pt idx="32">
                  <c:v>75.938181150000005</c:v>
                </c:pt>
                <c:pt idx="33">
                  <c:v>38.358453900000008</c:v>
                </c:pt>
                <c:pt idx="34">
                  <c:v>17.692451550000001</c:v>
                </c:pt>
                <c:pt idx="35">
                  <c:v>21.062938200000001</c:v>
                </c:pt>
                <c:pt idx="36">
                  <c:v>58.544415899999997</c:v>
                </c:pt>
                <c:pt idx="37">
                  <c:v>21.774523949999999</c:v>
                </c:pt>
                <c:pt idx="38">
                  <c:v>45.145485000000001</c:v>
                </c:pt>
                <c:pt idx="39">
                  <c:v>40.079654999999995</c:v>
                </c:pt>
                <c:pt idx="40">
                  <c:v>44.34375</c:v>
                </c:pt>
                <c:pt idx="41">
                  <c:v>48.877454999999998</c:v>
                </c:pt>
                <c:pt idx="42">
                  <c:v>38.724509999999995</c:v>
                </c:pt>
                <c:pt idx="43">
                  <c:v>42.548346300000006</c:v>
                </c:pt>
                <c:pt idx="44">
                  <c:v>28.901312400000002</c:v>
                </c:pt>
                <c:pt idx="45">
                  <c:v>27.8140587</c:v>
                </c:pt>
                <c:pt idx="46">
                  <c:v>19.730563799999999</c:v>
                </c:pt>
                <c:pt idx="47">
                  <c:v>33.413960699999997</c:v>
                </c:pt>
                <c:pt idx="48">
                  <c:v>33.8430441</c:v>
                </c:pt>
                <c:pt idx="49">
                  <c:v>13.651441950000002</c:v>
                </c:pt>
                <c:pt idx="50">
                  <c:v>67.821330599999996</c:v>
                </c:pt>
                <c:pt idx="51">
                  <c:v>39.426917399999994</c:v>
                </c:pt>
                <c:pt idx="52">
                  <c:v>56.982957449999994</c:v>
                </c:pt>
                <c:pt idx="53">
                  <c:v>40.547749499999995</c:v>
                </c:pt>
                <c:pt idx="54">
                  <c:v>25.845524999999999</c:v>
                </c:pt>
                <c:pt idx="55">
                  <c:v>67.16984579999999</c:v>
                </c:pt>
                <c:pt idx="56">
                  <c:v>51.940592999999993</c:v>
                </c:pt>
                <c:pt idx="57">
                  <c:v>30.472765199999998</c:v>
                </c:pt>
                <c:pt idx="58">
                  <c:v>33.556403700000004</c:v>
                </c:pt>
                <c:pt idx="59">
                  <c:v>39.502843199999994</c:v>
                </c:pt>
                <c:pt idx="60">
                  <c:v>55.393965899999991</c:v>
                </c:pt>
                <c:pt idx="61">
                  <c:v>57.609573300000001</c:v>
                </c:pt>
                <c:pt idx="62">
                  <c:v>56.785337100000007</c:v>
                </c:pt>
                <c:pt idx="63">
                  <c:v>47.507008499999998</c:v>
                </c:pt>
                <c:pt idx="64">
                  <c:v>46.163188499999997</c:v>
                </c:pt>
                <c:pt idx="65">
                  <c:v>78.137857200000013</c:v>
                </c:pt>
                <c:pt idx="66">
                  <c:v>20.781270899999999</c:v>
                </c:pt>
                <c:pt idx="67">
                  <c:v>31.814464499999989</c:v>
                </c:pt>
                <c:pt idx="68">
                  <c:v>35.297164499999994</c:v>
                </c:pt>
                <c:pt idx="69">
                  <c:v>21.628163700000002</c:v>
                </c:pt>
                <c:pt idx="70">
                  <c:v>23.051718300000001</c:v>
                </c:pt>
                <c:pt idx="71">
                  <c:v>26.755074449999999</c:v>
                </c:pt>
                <c:pt idx="72">
                  <c:v>21.656352899999998</c:v>
                </c:pt>
                <c:pt idx="73">
                  <c:v>50.916742500000005</c:v>
                </c:pt>
                <c:pt idx="74">
                  <c:v>50.703088049999991</c:v>
                </c:pt>
                <c:pt idx="75">
                  <c:v>23.135214749999996</c:v>
                </c:pt>
                <c:pt idx="76">
                  <c:v>27.217287150000001</c:v>
                </c:pt>
                <c:pt idx="77">
                  <c:v>38.047275149999997</c:v>
                </c:pt>
                <c:pt idx="78">
                  <c:v>50.800280249999993</c:v>
                </c:pt>
                <c:pt idx="79">
                  <c:v>23.569108499999999</c:v>
                </c:pt>
              </c:numCache>
            </c:numRef>
          </c:xVal>
          <c:yVal>
            <c:numRef>
              <c:f>RA!$E$2:$E$81</c:f>
              <c:numCache>
                <c:formatCode>0</c:formatCode>
                <c:ptCount val="80"/>
                <c:pt idx="0">
                  <c:v>7.6439627999999997</c:v>
                </c:pt>
                <c:pt idx="1">
                  <c:v>19.560850349999992</c:v>
                </c:pt>
                <c:pt idx="2">
                  <c:v>8.6404529999999991</c:v>
                </c:pt>
                <c:pt idx="3">
                  <c:v>9.9207536999999988</c:v>
                </c:pt>
                <c:pt idx="4">
                  <c:v>9.3625930499999992</c:v>
                </c:pt>
                <c:pt idx="5">
                  <c:v>8.719222499999999</c:v>
                </c:pt>
                <c:pt idx="6">
                  <c:v>32.432938499999999</c:v>
                </c:pt>
                <c:pt idx="7">
                  <c:v>19.680071999999999</c:v>
                </c:pt>
                <c:pt idx="8">
                  <c:v>11.127847499999998</c:v>
                </c:pt>
                <c:pt idx="9">
                  <c:v>16.380962700000001</c:v>
                </c:pt>
                <c:pt idx="10">
                  <c:v>8.5012410000000003</c:v>
                </c:pt>
                <c:pt idx="11">
                  <c:v>7.0974646500000009</c:v>
                </c:pt>
                <c:pt idx="12">
                  <c:v>4.5042289499999999</c:v>
                </c:pt>
                <c:pt idx="13">
                  <c:v>19.088500799999998</c:v>
                </c:pt>
                <c:pt idx="14">
                  <c:v>10.4774274</c:v>
                </c:pt>
                <c:pt idx="15">
                  <c:v>5.2554829499999993</c:v>
                </c:pt>
                <c:pt idx="16">
                  <c:v>18.1443285</c:v>
                </c:pt>
                <c:pt idx="17">
                  <c:v>13.0196457</c:v>
                </c:pt>
                <c:pt idx="18">
                  <c:v>18.845283150000004</c:v>
                </c:pt>
                <c:pt idx="19">
                  <c:v>14.466661800000002</c:v>
                </c:pt>
                <c:pt idx="20">
                  <c:v>9.9781554000000021</c:v>
                </c:pt>
                <c:pt idx="21">
                  <c:v>8.6291837999999998</c:v>
                </c:pt>
                <c:pt idx="22">
                  <c:v>15.492001200000001</c:v>
                </c:pt>
                <c:pt idx="23">
                  <c:v>16.834923600000003</c:v>
                </c:pt>
                <c:pt idx="24">
                  <c:v>14.482668299999997</c:v>
                </c:pt>
                <c:pt idx="25">
                  <c:v>13.365901499999994</c:v>
                </c:pt>
                <c:pt idx="26">
                  <c:v>10.262701799999999</c:v>
                </c:pt>
                <c:pt idx="27">
                  <c:v>6.0908717999999995</c:v>
                </c:pt>
                <c:pt idx="28">
                  <c:v>6.9284469</c:v>
                </c:pt>
                <c:pt idx="29">
                  <c:v>3.2596219500000001</c:v>
                </c:pt>
                <c:pt idx="30">
                  <c:v>12.334093200000002</c:v>
                </c:pt>
                <c:pt idx="31">
                  <c:v>7.4356756500000012</c:v>
                </c:pt>
                <c:pt idx="32">
                  <c:v>13.990858049999998</c:v>
                </c:pt>
                <c:pt idx="33">
                  <c:v>16.765310249999999</c:v>
                </c:pt>
                <c:pt idx="34">
                  <c:v>9.1965198000000026</c:v>
                </c:pt>
                <c:pt idx="35">
                  <c:v>8.8908848999999996</c:v>
                </c:pt>
                <c:pt idx="36">
                  <c:v>17.9843817</c:v>
                </c:pt>
                <c:pt idx="37">
                  <c:v>7.623701999999998</c:v>
                </c:pt>
                <c:pt idx="38">
                  <c:v>19.359029549999995</c:v>
                </c:pt>
                <c:pt idx="39">
                  <c:v>22.812057299999999</c:v>
                </c:pt>
                <c:pt idx="40">
                  <c:v>22.408415699999995</c:v>
                </c:pt>
                <c:pt idx="41">
                  <c:v>18.4602963</c:v>
                </c:pt>
                <c:pt idx="42">
                  <c:v>20.674018199999999</c:v>
                </c:pt>
                <c:pt idx="43">
                  <c:v>16.198805999999998</c:v>
                </c:pt>
                <c:pt idx="44">
                  <c:v>15.5597175</c:v>
                </c:pt>
                <c:pt idx="45">
                  <c:v>11.326960499999998</c:v>
                </c:pt>
                <c:pt idx="46">
                  <c:v>12.142681499999998</c:v>
                </c:pt>
                <c:pt idx="47">
                  <c:v>16.054288499999998</c:v>
                </c:pt>
                <c:pt idx="48">
                  <c:v>18.430798500000002</c:v>
                </c:pt>
                <c:pt idx="49">
                  <c:v>6.1794735000000003</c:v>
                </c:pt>
                <c:pt idx="50">
                  <c:v>20.760173399999999</c:v>
                </c:pt>
                <c:pt idx="51">
                  <c:v>14.587843799999998</c:v>
                </c:pt>
                <c:pt idx="52">
                  <c:v>39.044985449999999</c:v>
                </c:pt>
                <c:pt idx="53">
                  <c:v>16.956046650000001</c:v>
                </c:pt>
                <c:pt idx="54">
                  <c:v>12.325398749999998</c:v>
                </c:pt>
                <c:pt idx="55">
                  <c:v>22.309810200000005</c:v>
                </c:pt>
                <c:pt idx="56">
                  <c:v>10.72896615</c:v>
                </c:pt>
                <c:pt idx="57">
                  <c:v>10.960381799999999</c:v>
                </c:pt>
                <c:pt idx="58">
                  <c:v>15.59875635</c:v>
                </c:pt>
                <c:pt idx="59">
                  <c:v>18.068960400000002</c:v>
                </c:pt>
                <c:pt idx="60">
                  <c:v>27.732557400000001</c:v>
                </c:pt>
                <c:pt idx="61">
                  <c:v>19.175964</c:v>
                </c:pt>
                <c:pt idx="62">
                  <c:v>17.839090800000005</c:v>
                </c:pt>
                <c:pt idx="63">
                  <c:v>13.837545000000004</c:v>
                </c:pt>
                <c:pt idx="64">
                  <c:v>26.253647099999998</c:v>
                </c:pt>
                <c:pt idx="65">
                  <c:v>22.495790999999997</c:v>
                </c:pt>
                <c:pt idx="66">
                  <c:v>10.622120999999998</c:v>
                </c:pt>
                <c:pt idx="67">
                  <c:v>15.3908436</c:v>
                </c:pt>
                <c:pt idx="68">
                  <c:v>6.5208912000000003</c:v>
                </c:pt>
                <c:pt idx="69">
                  <c:v>8.9990004000000017</c:v>
                </c:pt>
                <c:pt idx="70">
                  <c:v>8.6647723499999998</c:v>
                </c:pt>
                <c:pt idx="71">
                  <c:v>13.803977850000001</c:v>
                </c:pt>
                <c:pt idx="72">
                  <c:v>12.075336</c:v>
                </c:pt>
                <c:pt idx="73">
                  <c:v>13.538032949999998</c:v>
                </c:pt>
                <c:pt idx="74">
                  <c:v>18.932193299999998</c:v>
                </c:pt>
                <c:pt idx="75">
                  <c:v>11.332529999999998</c:v>
                </c:pt>
                <c:pt idx="76">
                  <c:v>12.781720200000004</c:v>
                </c:pt>
                <c:pt idx="77">
                  <c:v>18.049629599999999</c:v>
                </c:pt>
                <c:pt idx="78">
                  <c:v>14.989846500000001</c:v>
                </c:pt>
                <c:pt idx="79">
                  <c:v>15.2027607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B2E-4DD3-B4DE-0DD3CD2A48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0854288"/>
        <c:axId val="220852656"/>
      </c:scatterChart>
      <c:valAx>
        <c:axId val="2208542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b="1"/>
                  <a:t>anti-TdEno Ab (mg/ml)</a:t>
                </a:r>
                <a:endParaRPr lang="ko-KR" b="1"/>
              </a:p>
            </c:rich>
          </c:tx>
          <c:layout>
            <c:manualLayout>
              <c:xMode val="edge"/>
              <c:yMode val="edge"/>
              <c:x val="0.3275476307649044"/>
              <c:y val="0.856062457841624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220852656"/>
        <c:crosses val="autoZero"/>
        <c:crossBetween val="midCat"/>
        <c:majorUnit val="25"/>
      </c:valAx>
      <c:valAx>
        <c:axId val="220852656"/>
        <c:scaling>
          <c:orientation val="minMax"/>
          <c:max val="4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b="1"/>
                  <a:t>anti-ENO1 Ab (mg/ml)</a:t>
                </a:r>
                <a:endParaRPr lang="ko-KR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220854288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6977" cy="513789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4020650" y="0"/>
            <a:ext cx="3076976" cy="513789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25EA21F5-389D-4E59-B466-D4166F99D392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491" tIns="47745" rIns="95491" bIns="47745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9428" y="4925460"/>
            <a:ext cx="5680444" cy="4029621"/>
          </a:xfrm>
          <a:prstGeom prst="rect">
            <a:avLst/>
          </a:prstGeom>
        </p:spPr>
        <p:txBody>
          <a:bodyPr vert="horz" lIns="95491" tIns="47745" rIns="95491" bIns="47745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720824"/>
            <a:ext cx="3076977" cy="513789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4020650" y="9720824"/>
            <a:ext cx="3076976" cy="513789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867A0D5D-1A50-4234-B262-8478BC7A1B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584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0023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6498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391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510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0718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8215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7213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0577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0068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3578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6708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B4DF85-C318-4AE9-B03D-7C9D0475E95A}" type="datetimeFigureOut">
              <a:rPr lang="ko-KR" altLang="en-US" smtClean="0"/>
              <a:t>2018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7B3A2-5868-4EF9-8C24-7B3800A32E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731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4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차트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742086"/>
              </p:ext>
            </p:extLst>
          </p:nvPr>
        </p:nvGraphicFramePr>
        <p:xfrm>
          <a:off x="4018972" y="3896856"/>
          <a:ext cx="2279284" cy="1989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4" name="그룹 23">
            <a:extLst>
              <a:ext uri="{FF2B5EF4-FFF2-40B4-BE49-F238E27FC236}">
                <a16:creationId xmlns:a16="http://schemas.microsoft.com/office/drawing/2014/main" id="{7466FE5C-8B65-43A1-B7D1-AD49B700CDE9}"/>
              </a:ext>
            </a:extLst>
          </p:cNvPr>
          <p:cNvGrpSpPr/>
          <p:nvPr/>
        </p:nvGrpSpPr>
        <p:grpSpPr>
          <a:xfrm>
            <a:off x="2149306" y="4137748"/>
            <a:ext cx="2135225" cy="1604963"/>
            <a:chOff x="3165797" y="2336285"/>
            <a:chExt cx="2135225" cy="1604963"/>
          </a:xfrm>
        </p:grpSpPr>
        <p:graphicFrame>
          <p:nvGraphicFramePr>
            <p:cNvPr id="25" name="개체 24">
              <a:extLst>
                <a:ext uri="{FF2B5EF4-FFF2-40B4-BE49-F238E27FC236}">
                  <a16:creationId xmlns:a16="http://schemas.microsoft.com/office/drawing/2014/main" id="{429C0E5D-4CB2-4EF4-9809-AFD8D4C3D5B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5218816"/>
                </p:ext>
              </p:extLst>
            </p:nvPr>
          </p:nvGraphicFramePr>
          <p:xfrm>
            <a:off x="3251560" y="2336285"/>
            <a:ext cx="2049462" cy="1604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34" name="Prism 6" r:id="rId4" imgW="2724427" imgH="2643891" progId="Prism6.Document">
                    <p:embed/>
                  </p:oleObj>
                </mc:Choice>
                <mc:Fallback>
                  <p:oleObj name="Prism 6" r:id="rId4" imgW="2724427" imgH="2643891" progId="Prism6.Document">
                    <p:embed/>
                    <p:pic>
                      <p:nvPicPr>
                        <p:cNvPr id="25" name="개체 24">
                          <a:extLst>
                            <a:ext uri="{FF2B5EF4-FFF2-40B4-BE49-F238E27FC236}">
                              <a16:creationId xmlns:a16="http://schemas.microsoft.com/office/drawing/2014/main" id="{429C0E5D-4CB2-4EF4-9809-AFD8D4C3D5B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251560" y="2336285"/>
                          <a:ext cx="2049462" cy="1604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81D238C-DFD1-457A-B6B0-4FA4FA6E1545}"/>
                </a:ext>
              </a:extLst>
            </p:cNvPr>
            <p:cNvSpPr txBox="1"/>
            <p:nvPr/>
          </p:nvSpPr>
          <p:spPr>
            <a:xfrm rot="16200000">
              <a:off x="2610196" y="2916397"/>
              <a:ext cx="13420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ti-ENO1 Ab (</a:t>
              </a:r>
              <a:r>
                <a:rPr lang="en-US" altLang="ko-KR" sz="900" b="1" dirty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/ml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7A10CD7A-B655-4D87-9B38-168FE50BCC53}"/>
              </a:ext>
            </a:extLst>
          </p:cNvPr>
          <p:cNvSpPr txBox="1"/>
          <p:nvPr/>
        </p:nvSpPr>
        <p:spPr>
          <a:xfrm>
            <a:off x="4714645" y="3851135"/>
            <a:ext cx="6767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r = 0.737</a:t>
            </a:r>
          </a:p>
          <a:p>
            <a:r>
              <a:rPr lang="en-US" altLang="ko-KR" sz="8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dirty="0">
                <a:latin typeface="Arial" pitchFamily="34" charset="0"/>
                <a:cs typeface="Arial" pitchFamily="34" charset="0"/>
              </a:rPr>
              <a:t> &lt; 0.0001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7" name="그룹 26">
            <a:extLst>
              <a:ext uri="{FF2B5EF4-FFF2-40B4-BE49-F238E27FC236}">
                <a16:creationId xmlns:a16="http://schemas.microsoft.com/office/drawing/2014/main" id="{DB2FD502-DA39-4374-B7B3-B607C78A5D98}"/>
              </a:ext>
            </a:extLst>
          </p:cNvPr>
          <p:cNvGrpSpPr/>
          <p:nvPr/>
        </p:nvGrpSpPr>
        <p:grpSpPr>
          <a:xfrm>
            <a:off x="372442" y="4131970"/>
            <a:ext cx="2122447" cy="1604963"/>
            <a:chOff x="3207959" y="2936643"/>
            <a:chExt cx="2122447" cy="1604963"/>
          </a:xfrm>
        </p:grpSpPr>
        <p:graphicFrame>
          <p:nvGraphicFramePr>
            <p:cNvPr id="28" name="개체 27">
              <a:extLst>
                <a:ext uri="{FF2B5EF4-FFF2-40B4-BE49-F238E27FC236}">
                  <a16:creationId xmlns:a16="http://schemas.microsoft.com/office/drawing/2014/main" id="{B603D3E1-033D-4EC1-BF1A-0607C619406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23334139"/>
                </p:ext>
              </p:extLst>
            </p:nvPr>
          </p:nvGraphicFramePr>
          <p:xfrm>
            <a:off x="3279356" y="2936643"/>
            <a:ext cx="2051050" cy="1604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35" name="Prism 6" r:id="rId6" imgW="2724427" imgH="2643891" progId="Prism6.Document">
                    <p:embed/>
                  </p:oleObj>
                </mc:Choice>
                <mc:Fallback>
                  <p:oleObj name="Prism 6" r:id="rId6" imgW="2724427" imgH="2643891" progId="Prism6.Document">
                    <p:embed/>
                    <p:pic>
                      <p:nvPicPr>
                        <p:cNvPr id="28" name="개체 27">
                          <a:extLst>
                            <a:ext uri="{FF2B5EF4-FFF2-40B4-BE49-F238E27FC236}">
                              <a16:creationId xmlns:a16="http://schemas.microsoft.com/office/drawing/2014/main" id="{B603D3E1-033D-4EC1-BF1A-0607C61940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279356" y="2936643"/>
                          <a:ext cx="2051050" cy="1604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C41EB08-0054-4124-9F73-A9F4119B88CC}"/>
                </a:ext>
              </a:extLst>
            </p:cNvPr>
            <p:cNvSpPr txBox="1"/>
            <p:nvPr/>
          </p:nvSpPr>
          <p:spPr>
            <a:xfrm rot="16200000">
              <a:off x="2599996" y="3547133"/>
              <a:ext cx="1438963" cy="223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dEno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Ab (</a:t>
              </a:r>
              <a:r>
                <a:rPr lang="en-US" altLang="ko-KR" sz="900" b="1" dirty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/ml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오른쪽 대괄호 36">
            <a:extLst>
              <a:ext uri="{FF2B5EF4-FFF2-40B4-BE49-F238E27FC236}">
                <a16:creationId xmlns:a16="http://schemas.microsoft.com/office/drawing/2014/main" id="{5A66C8C3-EDDA-4E41-9CD2-A5DAB81E34D6}"/>
              </a:ext>
            </a:extLst>
          </p:cNvPr>
          <p:cNvSpPr/>
          <p:nvPr/>
        </p:nvSpPr>
        <p:spPr>
          <a:xfrm rot="16200000">
            <a:off x="1419873" y="4094182"/>
            <a:ext cx="45721" cy="43711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D420C59-9269-4FF4-9F1A-67D1BA06E455}"/>
              </a:ext>
            </a:extLst>
          </p:cNvPr>
          <p:cNvSpPr txBox="1"/>
          <p:nvPr/>
        </p:nvSpPr>
        <p:spPr>
          <a:xfrm>
            <a:off x="1132256" y="4074273"/>
            <a:ext cx="6156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i="1" dirty="0"/>
              <a:t>p</a:t>
            </a:r>
            <a:r>
              <a:rPr lang="ko-KR" altLang="en-US" sz="900" dirty="0"/>
              <a:t> </a:t>
            </a:r>
            <a:r>
              <a:rPr lang="en-US" altLang="ko-KR" sz="900" dirty="0"/>
              <a:t>=</a:t>
            </a:r>
            <a:r>
              <a:rPr lang="ko-KR" altLang="en-US" sz="900" dirty="0"/>
              <a:t> </a:t>
            </a:r>
            <a:r>
              <a:rPr lang="en-US" altLang="ko-KR" sz="900" dirty="0"/>
              <a:t>0.083</a:t>
            </a:r>
            <a:endParaRPr lang="ko-KR" altLang="en-US" sz="9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8FB1223-A289-4F4C-BFCB-8540CF112F0B}"/>
              </a:ext>
            </a:extLst>
          </p:cNvPr>
          <p:cNvSpPr txBox="1"/>
          <p:nvPr/>
        </p:nvSpPr>
        <p:spPr>
          <a:xfrm>
            <a:off x="316269" y="1133931"/>
            <a:ext cx="59819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Table 1. Periodontal parameters of non-RA subjects with healthy periodontium or slight periodontitis</a:t>
            </a:r>
            <a:endParaRPr lang="ko-KR" altLang="en-US" sz="120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14D7DB3-E50E-46A2-AEC4-F590869A1885}"/>
              </a:ext>
            </a:extLst>
          </p:cNvPr>
          <p:cNvSpPr txBox="1"/>
          <p:nvPr/>
        </p:nvSpPr>
        <p:spPr>
          <a:xfrm>
            <a:off x="316267" y="3418636"/>
            <a:ext cx="5130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*mean ± standard deviation, </a:t>
            </a:r>
            <a:r>
              <a:rPr lang="en-US" altLang="ko-KR" sz="1200" baseline="30000" dirty="0" err="1"/>
              <a:t>ǂ</a:t>
            </a:r>
            <a:r>
              <a:rPr lang="en-US" altLang="ko-KR" sz="1200" dirty="0" err="1"/>
              <a:t>by</a:t>
            </a:r>
            <a:r>
              <a:rPr lang="en-US" altLang="ko-KR" sz="1200" dirty="0"/>
              <a:t> Fisher’s exact test, </a:t>
            </a:r>
            <a:r>
              <a:rPr lang="en-US" altLang="ko-KR" sz="1200" baseline="30000" dirty="0"/>
              <a:t>#</a:t>
            </a:r>
            <a:r>
              <a:rPr lang="en-US" altLang="ko-KR" sz="1200" dirty="0"/>
              <a:t>by Mann-Whitney U test </a:t>
            </a:r>
            <a:endParaRPr lang="ko-KR" altLang="en-US" sz="12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520F7D-33E1-4391-91AE-CD9F7DD12E3E}"/>
              </a:ext>
            </a:extLst>
          </p:cNvPr>
          <p:cNvSpPr txBox="1"/>
          <p:nvPr/>
        </p:nvSpPr>
        <p:spPr>
          <a:xfrm>
            <a:off x="267619" y="39185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723CF52-A5EF-4913-8C8C-124EAA7EB907}"/>
              </a:ext>
            </a:extLst>
          </p:cNvPr>
          <p:cNvSpPr txBox="1"/>
          <p:nvPr/>
        </p:nvSpPr>
        <p:spPr>
          <a:xfrm>
            <a:off x="4075481" y="392623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0A2CD19-2C7B-45F4-9354-63BAC4234E02}"/>
              </a:ext>
            </a:extLst>
          </p:cNvPr>
          <p:cNvSpPr txBox="1"/>
          <p:nvPr/>
        </p:nvSpPr>
        <p:spPr>
          <a:xfrm>
            <a:off x="370212" y="6274511"/>
            <a:ext cx="61175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Figure 1. </a:t>
            </a:r>
            <a:r>
              <a:rPr lang="en-US" altLang="ko-KR" sz="1200" dirty="0"/>
              <a:t>(A) Concentrations of anti-TdEno and anti-ENO1 IgG antibodies in sera from periodontally healthy subjects (n = 20) and slight periodontitis patients (n = 23) were determined by ELISA. (B) Spearman’s correlation between the levels of anti-TdEno and anti-ENO1 antibodies is shown. </a:t>
            </a:r>
            <a:endParaRPr lang="ko-KR" altLang="en-US" sz="1200" dirty="0"/>
          </a:p>
        </p:txBody>
      </p:sp>
      <p:graphicFrame>
        <p:nvGraphicFramePr>
          <p:cNvPr id="32" name="표 31">
            <a:extLst>
              <a:ext uri="{FF2B5EF4-FFF2-40B4-BE49-F238E27FC236}">
                <a16:creationId xmlns:a16="http://schemas.microsoft.com/office/drawing/2014/main" id="{5C730146-25A0-417F-A405-4DA79C92E1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5048719"/>
              </p:ext>
            </p:extLst>
          </p:nvPr>
        </p:nvGraphicFramePr>
        <p:xfrm>
          <a:off x="361980" y="1574122"/>
          <a:ext cx="5936276" cy="1865716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288954">
                  <a:extLst>
                    <a:ext uri="{9D8B030D-6E8A-4147-A177-3AD203B41FA5}">
                      <a16:colId xmlns:a16="http://schemas.microsoft.com/office/drawing/2014/main" val="3808974235"/>
                    </a:ext>
                  </a:extLst>
                </a:gridCol>
                <a:gridCol w="1003897">
                  <a:extLst>
                    <a:ext uri="{9D8B030D-6E8A-4147-A177-3AD203B41FA5}">
                      <a16:colId xmlns:a16="http://schemas.microsoft.com/office/drawing/2014/main" val="1407522581"/>
                    </a:ext>
                  </a:extLst>
                </a:gridCol>
                <a:gridCol w="1461228">
                  <a:extLst>
                    <a:ext uri="{9D8B030D-6E8A-4147-A177-3AD203B41FA5}">
                      <a16:colId xmlns:a16="http://schemas.microsoft.com/office/drawing/2014/main" val="3876685279"/>
                    </a:ext>
                  </a:extLst>
                </a:gridCol>
                <a:gridCol w="1552941">
                  <a:extLst>
                    <a:ext uri="{9D8B030D-6E8A-4147-A177-3AD203B41FA5}">
                      <a16:colId xmlns:a16="http://schemas.microsoft.com/office/drawing/2014/main" val="4263844303"/>
                    </a:ext>
                  </a:extLst>
                </a:gridCol>
                <a:gridCol w="629256">
                  <a:extLst>
                    <a:ext uri="{9D8B030D-6E8A-4147-A177-3AD203B41FA5}">
                      <a16:colId xmlns:a16="http://schemas.microsoft.com/office/drawing/2014/main" val="3363624453"/>
                    </a:ext>
                  </a:extLst>
                </a:gridCol>
              </a:tblGrid>
              <a:tr h="363535">
                <a:tc>
                  <a:txBody>
                    <a:bodyPr/>
                    <a:lstStyle/>
                    <a:p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Healthy</a:t>
                      </a:r>
                    </a:p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altLang="ko-KR" sz="1200" kern="0" dirty="0">
                          <a:effectLst/>
                        </a:rPr>
                        <a:t>(n = 20)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Slight</a:t>
                      </a:r>
                      <a:r>
                        <a:rPr lang="en-US" sz="1200" kern="0" baseline="0" dirty="0">
                          <a:effectLst/>
                        </a:rPr>
                        <a:t> p</a:t>
                      </a:r>
                      <a:r>
                        <a:rPr lang="en-US" sz="1200" kern="0" dirty="0">
                          <a:effectLst/>
                        </a:rPr>
                        <a:t>eriodontitis</a:t>
                      </a:r>
                      <a:endParaRPr lang="ko-KR" sz="1000" kern="100" dirty="0">
                        <a:effectLst/>
                      </a:endParaRPr>
                    </a:p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 (n = 23)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P value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3178295792"/>
                  </a:ext>
                </a:extLst>
              </a:tr>
              <a:tr h="181768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</a:rPr>
                        <a:t>Age</a:t>
                      </a:r>
                      <a:r>
                        <a:rPr lang="en-US" sz="1200" kern="0" baseline="30000">
                          <a:effectLst/>
                        </a:rPr>
                        <a:t>*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</a:rPr>
                        <a:t>44.7 ± 14.9</a:t>
                      </a:r>
                      <a:endParaRPr lang="ko-KR" altLang="ko-KR" sz="1100" b="0" kern="100" dirty="0">
                        <a:effectLst/>
                        <a:latin typeface="맑은 고딕" panose="020B0503020000020004" pitchFamily="50" charset="-127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</a:rPr>
                        <a:t>61.0 ± 8.9</a:t>
                      </a:r>
                      <a:endParaRPr lang="ko-KR" altLang="ko-KR" sz="1100" b="0" kern="100" dirty="0">
                        <a:effectLst/>
                        <a:latin typeface="맑은 고딕" panose="020B0503020000020004" pitchFamily="50" charset="-127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&lt;0.0001</a:t>
                      </a:r>
                      <a:r>
                        <a:rPr lang="en-US" altLang="ko-KR" sz="1100" baseline="30000" dirty="0"/>
                        <a:t>#</a:t>
                      </a:r>
                      <a:endParaRPr lang="ko-KR" sz="11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3413398227"/>
                  </a:ext>
                </a:extLst>
              </a:tr>
              <a:tr h="201338"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Female</a:t>
                      </a:r>
                      <a:r>
                        <a:rPr lang="ko-KR" altLang="en-US" sz="1200" kern="0" dirty="0">
                          <a:effectLst/>
                        </a:rPr>
                        <a:t> </a:t>
                      </a:r>
                      <a:r>
                        <a:rPr lang="en-US" sz="1200" kern="0" dirty="0">
                          <a:effectLst/>
                        </a:rPr>
                        <a:t>%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effectLst/>
                          <a:latin typeface="맑은 고딕" panose="020B0503020000020004" pitchFamily="50" charset="-127"/>
                          <a:ea typeface="+mn-ea"/>
                          <a:cs typeface="Times New Roman" panose="02020603050405020304" pitchFamily="18" charset="0"/>
                        </a:rPr>
                        <a:t>80</a:t>
                      </a:r>
                      <a:endParaRPr lang="ko-KR" altLang="ko-KR" sz="1100" b="0" kern="100" dirty="0">
                        <a:effectLst/>
                        <a:latin typeface="맑은 고딕" panose="020B0503020000020004" pitchFamily="50" charset="-127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</a:rPr>
                        <a:t>39.2</a:t>
                      </a:r>
                      <a:endParaRPr lang="ko-KR" altLang="ko-KR" sz="1100" b="0" kern="100" dirty="0">
                        <a:effectLst/>
                        <a:latin typeface="맑은 고딕" panose="020B0503020000020004" pitchFamily="50" charset="-127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0" dirty="0">
                          <a:effectLst/>
                          <a:latin typeface="+mn-lt"/>
                          <a:ea typeface="+mn-ea"/>
                          <a:cs typeface="+mn-cs"/>
                        </a:rPr>
                        <a:t>0.012</a:t>
                      </a:r>
                      <a:r>
                        <a:rPr lang="en-US" altLang="ko-KR" sz="1100" baseline="30000" dirty="0"/>
                        <a:t>ǂ</a:t>
                      </a:r>
                      <a:endParaRPr lang="ko-KR" altLang="ko-KR" sz="1100" b="0" kern="100" dirty="0">
                        <a:effectLst/>
                        <a:latin typeface="맑은 고딕" panose="020B0503020000020004" pitchFamily="50" charset="-127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2337741745"/>
                  </a:ext>
                </a:extLst>
              </a:tr>
              <a:tr h="201338"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000" kern="100" dirty="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moking %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ko-KR" sz="1100" b="0" kern="100" dirty="0"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8.3</a:t>
                      </a:r>
                      <a:endParaRPr lang="ko-KR" altLang="ko-KR" sz="1100" b="0" kern="100" dirty="0"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kern="100" dirty="0"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0.641</a:t>
                      </a:r>
                      <a:r>
                        <a:rPr lang="en-US" altLang="ko-KR" sz="1100" baseline="30000" dirty="0"/>
                        <a:t>ǂ</a:t>
                      </a:r>
                      <a:endParaRPr lang="ko-KR" altLang="ko-KR" sz="1100" b="0" kern="100" dirty="0"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2350225561"/>
                  </a:ext>
                </a:extLst>
              </a:tr>
              <a:tr h="102870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Number of tooth</a:t>
                      </a:r>
                      <a:r>
                        <a:rPr lang="en-US" sz="1200" kern="0" baseline="30000" dirty="0">
                          <a:effectLst/>
                        </a:rPr>
                        <a:t>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  <a:latin typeface="+mn-lt"/>
                        </a:rPr>
                        <a:t>28.3 ± 1.2</a:t>
                      </a:r>
                      <a:endParaRPr lang="ko-KR" altLang="ko-KR" sz="1100" b="0" kern="100" dirty="0"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+mn-lt"/>
                        </a:rPr>
                        <a:t>27.5 ± 2.0</a:t>
                      </a:r>
                      <a:endParaRPr lang="ko-KR" sz="1100" b="0" kern="100" dirty="0">
                        <a:effectLst/>
                        <a:latin typeface="+mn-lt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+mn-lt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306</a:t>
                      </a:r>
                      <a:r>
                        <a:rPr lang="en-US" altLang="ko-KR" sz="1100" baseline="30000" dirty="0">
                          <a:latin typeface="+mn-lt"/>
                        </a:rPr>
                        <a:t>#</a:t>
                      </a:r>
                      <a:endParaRPr lang="ko-KR" sz="1100" kern="100" dirty="0">
                        <a:effectLst/>
                        <a:latin typeface="+mn-lt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3715074342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Plaque index (PI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>
                          <a:effectLst/>
                        </a:rPr>
                        <a:t>1.0 ± 0.9</a:t>
                      </a:r>
                      <a:endParaRPr lang="ko-KR" sz="11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</a:rPr>
                        <a:t>0.95 ± 0.72</a:t>
                      </a:r>
                      <a:endParaRPr lang="ko-KR" sz="1100" b="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909</a:t>
                      </a:r>
                      <a:r>
                        <a:rPr lang="en-US" altLang="ko-KR" sz="1100" baseline="30000" dirty="0"/>
                        <a:t>#</a:t>
                      </a:r>
                      <a:endParaRPr lang="ko-KR" sz="11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2874931953"/>
                  </a:ext>
                </a:extLst>
              </a:tr>
              <a:tr h="181768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Bleeding on probing (BOP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>
                          <a:effectLst/>
                        </a:rPr>
                        <a:t>0.65 ± 0.31</a:t>
                      </a:r>
                      <a:endParaRPr lang="ko-KR" sz="11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</a:rPr>
                        <a:t>0.84 ± 0.16</a:t>
                      </a:r>
                      <a:endParaRPr lang="ko-KR" sz="1100" b="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080</a:t>
                      </a:r>
                      <a:r>
                        <a:rPr lang="en-US" altLang="ko-KR" sz="1100" baseline="30000" dirty="0"/>
                        <a:t>#</a:t>
                      </a:r>
                      <a:endParaRPr lang="ko-KR" sz="11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720155760"/>
                  </a:ext>
                </a:extLst>
              </a:tr>
              <a:tr h="181768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Probing pocket depth (PPD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>
                          <a:effectLst/>
                        </a:rPr>
                        <a:t>2.22 ± 0.25</a:t>
                      </a:r>
                      <a:endParaRPr lang="ko-KR" sz="11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</a:rPr>
                        <a:t>2.50 ± 0.24</a:t>
                      </a:r>
                      <a:endParaRPr lang="ko-KR" sz="1100" b="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001</a:t>
                      </a:r>
                      <a:r>
                        <a:rPr lang="en-US" altLang="ko-KR" sz="1100" baseline="30000" dirty="0"/>
                        <a:t>#</a:t>
                      </a:r>
                      <a:endParaRPr lang="ko-KR" sz="11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3804993067"/>
                  </a:ext>
                </a:extLst>
              </a:tr>
              <a:tr h="181768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Clinical attachment level (CAL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</a:rPr>
                        <a:t>2.22 ± 0.24</a:t>
                      </a:r>
                      <a:endParaRPr lang="ko-KR" sz="1100" b="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</a:rPr>
                        <a:t>2.51 ± 0.23</a:t>
                      </a:r>
                      <a:endParaRPr lang="ko-KR" sz="1100" b="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&lt;0.0001</a:t>
                      </a:r>
                      <a:r>
                        <a:rPr lang="en-US" altLang="ko-KR" sz="1100" baseline="30000" dirty="0"/>
                        <a:t>#</a:t>
                      </a:r>
                      <a:endParaRPr lang="ko-KR" sz="11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extLst>
                  <a:ext uri="{0D108BD9-81ED-4DB2-BD59-A6C34878D82A}">
                    <a16:rowId xmlns:a16="http://schemas.microsoft.com/office/drawing/2014/main" val="3306449584"/>
                  </a:ext>
                </a:extLst>
              </a:tr>
            </a:tbl>
          </a:graphicData>
        </a:graphic>
      </p:graphicFrame>
      <p:sp>
        <p:nvSpPr>
          <p:cNvPr id="20" name="오른쪽 대괄호 19">
            <a:extLst>
              <a:ext uri="{FF2B5EF4-FFF2-40B4-BE49-F238E27FC236}">
                <a16:creationId xmlns:a16="http://schemas.microsoft.com/office/drawing/2014/main" id="{19ED3F7A-2A12-4FCF-960E-23E2CAA07DB9}"/>
              </a:ext>
            </a:extLst>
          </p:cNvPr>
          <p:cNvSpPr/>
          <p:nvPr/>
        </p:nvSpPr>
        <p:spPr>
          <a:xfrm rot="16200000">
            <a:off x="3194226" y="4066564"/>
            <a:ext cx="45721" cy="43711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FEE0B13-9E16-4916-9A5B-B399C105849A}"/>
              </a:ext>
            </a:extLst>
          </p:cNvPr>
          <p:cNvSpPr txBox="1"/>
          <p:nvPr/>
        </p:nvSpPr>
        <p:spPr>
          <a:xfrm>
            <a:off x="2906609" y="4046655"/>
            <a:ext cx="6156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i="1" dirty="0"/>
              <a:t>p</a:t>
            </a:r>
            <a:r>
              <a:rPr lang="ko-KR" altLang="en-US" sz="900" dirty="0"/>
              <a:t> </a:t>
            </a:r>
            <a:r>
              <a:rPr lang="en-US" altLang="ko-KR" sz="900" dirty="0"/>
              <a:t>=</a:t>
            </a:r>
            <a:r>
              <a:rPr lang="ko-KR" altLang="en-US" sz="900" dirty="0"/>
              <a:t> </a:t>
            </a:r>
            <a:r>
              <a:rPr lang="en-US" altLang="ko-KR" sz="900" dirty="0"/>
              <a:t>0.096</a:t>
            </a:r>
            <a:endParaRPr lang="ko-KR" altLang="en-US" sz="900" dirty="0"/>
          </a:p>
        </p:txBody>
      </p:sp>
    </p:spTree>
    <p:extLst>
      <p:ext uri="{BB962C8B-B14F-4D97-AF65-F5344CB8AC3E}">
        <p14:creationId xmlns:p14="http://schemas.microsoft.com/office/powerpoint/2010/main" val="2305276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차트 20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21596236"/>
              </p:ext>
            </p:extLst>
          </p:nvPr>
        </p:nvGraphicFramePr>
        <p:xfrm>
          <a:off x="4210535" y="4616451"/>
          <a:ext cx="2087722" cy="18948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7A10CD7A-B655-4D87-9B38-168FE50BCC53}"/>
              </a:ext>
            </a:extLst>
          </p:cNvPr>
          <p:cNvSpPr txBox="1"/>
          <p:nvPr/>
        </p:nvSpPr>
        <p:spPr>
          <a:xfrm>
            <a:off x="4802756" y="4360487"/>
            <a:ext cx="6767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r = 0.759</a:t>
            </a:r>
          </a:p>
          <a:p>
            <a:r>
              <a:rPr lang="en-US" altLang="ko-KR" sz="8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dirty="0">
                <a:latin typeface="Arial" pitchFamily="34" charset="0"/>
                <a:cs typeface="Arial" pitchFamily="34" charset="0"/>
              </a:rPr>
              <a:t> &lt; 0.0001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14D7DB3-E50E-46A2-AEC4-F590869A1885}"/>
              </a:ext>
            </a:extLst>
          </p:cNvPr>
          <p:cNvSpPr txBox="1"/>
          <p:nvPr/>
        </p:nvSpPr>
        <p:spPr>
          <a:xfrm>
            <a:off x="535656" y="3644130"/>
            <a:ext cx="5719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*mean ± standard deviation, </a:t>
            </a:r>
            <a:r>
              <a:rPr lang="en-US" altLang="ko-KR" sz="1200" baseline="30000" dirty="0"/>
              <a:t>ǂ</a:t>
            </a:r>
            <a:r>
              <a:rPr lang="en-US" altLang="ko-KR" sz="1200" dirty="0"/>
              <a:t>by Fisher’s exact test, </a:t>
            </a:r>
            <a:r>
              <a:rPr lang="ko-KR" altLang="ko-KR" sz="1200" baseline="30000" dirty="0"/>
              <a:t>†</a:t>
            </a:r>
            <a:r>
              <a:rPr lang="en-US" altLang="ko-KR" sz="1200" dirty="0"/>
              <a:t>by t-test, </a:t>
            </a:r>
            <a:r>
              <a:rPr lang="en-US" altLang="ko-KR" sz="1200" baseline="30000" dirty="0"/>
              <a:t>#</a:t>
            </a:r>
            <a:r>
              <a:rPr lang="en-US" altLang="ko-KR" sz="1200" dirty="0"/>
              <a:t>by Mann-Whitney U test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520F7D-33E1-4391-91AE-CD9F7DD12E3E}"/>
              </a:ext>
            </a:extLst>
          </p:cNvPr>
          <p:cNvSpPr txBox="1"/>
          <p:nvPr/>
        </p:nvSpPr>
        <p:spPr>
          <a:xfrm>
            <a:off x="257178" y="4360487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723CF52-A5EF-4913-8C8C-124EAA7EB907}"/>
              </a:ext>
            </a:extLst>
          </p:cNvPr>
          <p:cNvSpPr txBox="1"/>
          <p:nvPr/>
        </p:nvSpPr>
        <p:spPr>
          <a:xfrm>
            <a:off x="4163014" y="4368171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graphicFrame>
        <p:nvGraphicFramePr>
          <p:cNvPr id="32" name="표 31">
            <a:extLst>
              <a:ext uri="{FF2B5EF4-FFF2-40B4-BE49-F238E27FC236}">
                <a16:creationId xmlns:a16="http://schemas.microsoft.com/office/drawing/2014/main" id="{5C730146-25A0-417F-A405-4DA79C92E1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712030"/>
              </p:ext>
            </p:extLst>
          </p:nvPr>
        </p:nvGraphicFramePr>
        <p:xfrm>
          <a:off x="535656" y="1519472"/>
          <a:ext cx="5991020" cy="2064422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288954">
                  <a:extLst>
                    <a:ext uri="{9D8B030D-6E8A-4147-A177-3AD203B41FA5}">
                      <a16:colId xmlns:a16="http://schemas.microsoft.com/office/drawing/2014/main" val="3808974235"/>
                    </a:ext>
                  </a:extLst>
                </a:gridCol>
                <a:gridCol w="1003897">
                  <a:extLst>
                    <a:ext uri="{9D8B030D-6E8A-4147-A177-3AD203B41FA5}">
                      <a16:colId xmlns:a16="http://schemas.microsoft.com/office/drawing/2014/main" val="1407522581"/>
                    </a:ext>
                  </a:extLst>
                </a:gridCol>
                <a:gridCol w="1461228">
                  <a:extLst>
                    <a:ext uri="{9D8B030D-6E8A-4147-A177-3AD203B41FA5}">
                      <a16:colId xmlns:a16="http://schemas.microsoft.com/office/drawing/2014/main" val="3876685279"/>
                    </a:ext>
                  </a:extLst>
                </a:gridCol>
                <a:gridCol w="1552941">
                  <a:extLst>
                    <a:ext uri="{9D8B030D-6E8A-4147-A177-3AD203B41FA5}">
                      <a16:colId xmlns:a16="http://schemas.microsoft.com/office/drawing/2014/main" val="4263844303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3363624453"/>
                    </a:ext>
                  </a:extLst>
                </a:gridCol>
              </a:tblGrid>
              <a:tr h="326073">
                <a:tc>
                  <a:txBody>
                    <a:bodyPr/>
                    <a:lstStyle/>
                    <a:p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Non-RA</a:t>
                      </a: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 (n = 50)</a:t>
                      </a:r>
                      <a:endParaRPr lang="ko-KR" sz="10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RA</a:t>
                      </a:r>
                      <a:endParaRPr lang="ko-KR" sz="10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 (n = 38)</a:t>
                      </a:r>
                      <a:endParaRPr lang="ko-KR" sz="10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p</a:t>
                      </a: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 value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178295792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ge</a:t>
                      </a:r>
                      <a:r>
                        <a:rPr lang="en-US" sz="1200" kern="0" baseline="30000" dirty="0">
                          <a:effectLst/>
                        </a:rPr>
                        <a:t>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6.9 ± 13.3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7.7 </a:t>
                      </a:r>
                      <a:r>
                        <a:rPr lang="en-US" sz="1100" kern="0" dirty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± 12.6</a:t>
                      </a:r>
                      <a:endParaRPr lang="ko-KR" sz="10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777</a:t>
                      </a:r>
                      <a:r>
                        <a:rPr lang="ko-KR" sz="1200" kern="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†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413398227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emale %</a:t>
                      </a:r>
                      <a:endParaRPr lang="ko-KR" altLang="ko-KR" sz="1200" kern="100" dirty="0">
                        <a:effectLst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8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0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671</a:t>
                      </a:r>
                      <a:r>
                        <a:rPr lang="en-US" sz="1200" kern="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ǂ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337741745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Smoking</a:t>
                      </a:r>
                      <a:r>
                        <a:rPr lang="en-US" altLang="ko-KR" sz="1200" kern="100" baseline="0" dirty="0"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 %</a:t>
                      </a:r>
                      <a:endParaRPr lang="ko-KR" altLang="ko-KR" sz="1200" kern="100" dirty="0">
                        <a:effectLst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.5</a:t>
                      </a:r>
                      <a:endParaRPr lang="ko-KR" sz="10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705</a:t>
                      </a:r>
                      <a:r>
                        <a:rPr lang="en-US" sz="1200" kern="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ǂ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793993229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200" kern="0" dirty="0">
                          <a:effectLst/>
                        </a:rPr>
                        <a:t>The</a:t>
                      </a:r>
                      <a:r>
                        <a:rPr lang="en-US" altLang="ko-KR" sz="1200" kern="0" baseline="0" dirty="0">
                          <a:effectLst/>
                        </a:rPr>
                        <a:t> n</a:t>
                      </a:r>
                      <a:r>
                        <a:rPr lang="en-US" altLang="ko-KR" sz="1200" kern="0" dirty="0">
                          <a:effectLst/>
                        </a:rPr>
                        <a:t>umber of tooth</a:t>
                      </a:r>
                      <a:r>
                        <a:rPr lang="en-US" altLang="ko-KR" sz="1200" kern="0" baseline="30000" dirty="0">
                          <a:effectLst/>
                        </a:rPr>
                        <a:t>*</a:t>
                      </a:r>
                      <a:endParaRPr lang="ko-KR" altLang="ko-KR" sz="1000" kern="100" dirty="0">
                        <a:effectLst/>
                        <a:latin typeface="맑은 고딕" panose="020B0503020000020004" pitchFamily="50" charset="-127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6.0 ± 2.8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5.6 ± 3.0 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290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715074342"/>
                  </a:ext>
                </a:extLst>
              </a:tr>
              <a:tr h="172946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Plaque index (PI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58 ± 0.25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29 </a:t>
                      </a: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± 0.26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 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&lt; 0.0001</a:t>
                      </a:r>
                      <a:r>
                        <a:rPr lang="en-US" sz="1200" kern="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#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874931953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altLang="ko-KR" sz="1000" kern="100" dirty="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ingival index</a:t>
                      </a:r>
                      <a:r>
                        <a:rPr lang="en-US" altLang="ko-KR" sz="1000" kern="100" baseline="0" dirty="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(GI) </a:t>
                      </a:r>
                      <a:r>
                        <a:rPr lang="en-US" altLang="ko-KR" sz="1000" kern="0" baseline="30000" dirty="0">
                          <a:effectLst/>
                        </a:rPr>
                        <a:t>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10 ± 0.15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.56 </a:t>
                      </a: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± 0.32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&lt; 0.0001</a:t>
                      </a:r>
                      <a:r>
                        <a:rPr lang="en-US" sz="1200" kern="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#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81092546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Bleeding on probing (BOP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.6 ± 7.2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7.9 </a:t>
                      </a: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± 9.8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&lt; 0.0001</a:t>
                      </a:r>
                      <a:r>
                        <a:rPr lang="en-US" sz="1200" kern="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#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720155760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Probing pocket depth (PPD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.65 ± 0.13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.42 </a:t>
                      </a: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± 0.14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&lt; 0.0001</a:t>
                      </a:r>
                      <a:r>
                        <a:rPr lang="en-US" sz="1200" kern="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#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804993067"/>
                  </a:ext>
                </a:extLst>
              </a:tr>
              <a:tr h="185076">
                <a:tc gridSpan="2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Clinical attachment level (CAL)</a:t>
                      </a:r>
                      <a:r>
                        <a:rPr lang="en-US" sz="1200" kern="0" baseline="30000" dirty="0">
                          <a:effectLst/>
                        </a:rPr>
                        <a:t> *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2188" marR="32188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.59 ± 0.21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.18 </a:t>
                      </a:r>
                      <a:r>
                        <a:rPr lang="en-US" sz="1100" kern="0"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± 0.21</a:t>
                      </a:r>
                      <a:endParaRPr lang="ko-KR" sz="10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&lt; 0.0001</a:t>
                      </a:r>
                      <a:r>
                        <a:rPr lang="en-US" sz="1200" kern="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#</a:t>
                      </a:r>
                      <a:endParaRPr lang="ko-KR" sz="10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306449584"/>
                  </a:ext>
                </a:extLst>
              </a:tr>
            </a:tbl>
          </a:graphicData>
        </a:graphic>
      </p:graphicFrame>
      <p:grpSp>
        <p:nvGrpSpPr>
          <p:cNvPr id="3" name="그룹 2"/>
          <p:cNvGrpSpPr/>
          <p:nvPr/>
        </p:nvGrpSpPr>
        <p:grpSpPr>
          <a:xfrm>
            <a:off x="412545" y="4616450"/>
            <a:ext cx="2108405" cy="1609725"/>
            <a:chOff x="412545" y="4616450"/>
            <a:chExt cx="2108405" cy="1609725"/>
          </a:xfrm>
        </p:grpSpPr>
        <p:graphicFrame>
          <p:nvGraphicFramePr>
            <p:cNvPr id="23" name="개체 22">
              <a:extLst>
                <a:ext uri="{FF2B5EF4-FFF2-40B4-BE49-F238E27FC236}">
                  <a16:creationId xmlns:a16="http://schemas.microsoft.com/office/drawing/2014/main" id="{B603D3E1-033D-4EC1-BF1A-0607C6194063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598488" y="4616450"/>
            <a:ext cx="1922462" cy="1609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44" name="Prism 6" r:id="rId4" imgW="3443978" imgH="2646772" progId="Prism6.Document">
                    <p:embed/>
                  </p:oleObj>
                </mc:Choice>
                <mc:Fallback>
                  <p:oleObj name="Prism 6" r:id="rId4" imgW="3443978" imgH="2646772" progId="Prism6.Document">
                    <p:embed/>
                    <p:pic>
                      <p:nvPicPr>
                        <p:cNvPr id="23" name="개체 22">
                          <a:extLst>
                            <a:ext uri="{FF2B5EF4-FFF2-40B4-BE49-F238E27FC236}">
                              <a16:creationId xmlns:a16="http://schemas.microsoft.com/office/drawing/2014/main" id="{B603D3E1-033D-4EC1-BF1A-0607C61940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98488" y="4616450"/>
                          <a:ext cx="1922462" cy="1609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C41EB08-0054-4124-9F73-A9F4119B88CC}"/>
                </a:ext>
              </a:extLst>
            </p:cNvPr>
            <p:cNvSpPr txBox="1"/>
            <p:nvPr/>
          </p:nvSpPr>
          <p:spPr>
            <a:xfrm rot="16200000">
              <a:off x="-166620" y="5215210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Calibri" panose="020F0502020204030204" pitchFamily="34" charset="0"/>
                  <a:cs typeface="Calibri" panose="020F0502020204030204" pitchFamily="34" charset="0"/>
                </a:rPr>
                <a:t>anti-TdEno Ab (</a:t>
              </a:r>
              <a:r>
                <a:rPr lang="en-US" altLang="ko-KR" sz="1000" b="1" dirty="0">
                  <a:latin typeface="Symbol" panose="05050102010706020507" pitchFamily="18" charset="2"/>
                  <a:cs typeface="Calibri" panose="020F0502020204030204" pitchFamily="34" charset="0"/>
                </a:rPr>
                <a:t>m</a:t>
              </a:r>
              <a:r>
                <a:rPr lang="en-US" altLang="ko-KR" sz="1000" b="1" dirty="0">
                  <a:latin typeface="Calibri" panose="020F0502020204030204" pitchFamily="34" charset="0"/>
                  <a:cs typeface="Calibri" panose="020F0502020204030204" pitchFamily="34" charset="0"/>
                </a:rPr>
                <a:t>g/ml)</a:t>
              </a:r>
              <a:endParaRPr lang="ko-KR" altLang="en-US" sz="1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2" name="그룹 1"/>
          <p:cNvGrpSpPr/>
          <p:nvPr/>
        </p:nvGrpSpPr>
        <p:grpSpPr>
          <a:xfrm>
            <a:off x="2269229" y="4625975"/>
            <a:ext cx="2039246" cy="1604963"/>
            <a:chOff x="2255911" y="4602435"/>
            <a:chExt cx="2039246" cy="1604963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81D238C-DFD1-457A-B6B0-4FA4FA6E1545}"/>
                </a:ext>
              </a:extLst>
            </p:cNvPr>
            <p:cNvSpPr txBox="1"/>
            <p:nvPr/>
          </p:nvSpPr>
          <p:spPr>
            <a:xfrm rot="16200000">
              <a:off x="1693578" y="5177599"/>
              <a:ext cx="13708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Calibri" panose="020F0502020204030204" pitchFamily="34" charset="0"/>
                  <a:cs typeface="Calibri" panose="020F0502020204030204" pitchFamily="34" charset="0"/>
                </a:rPr>
                <a:t>anti-ENO1 Ab (</a:t>
              </a:r>
              <a:r>
                <a:rPr lang="en-US" altLang="ko-KR" sz="1000" b="1" dirty="0">
                  <a:latin typeface="Symbol" panose="05050102010706020507" pitchFamily="18" charset="2"/>
                  <a:cs typeface="Calibri" panose="020F0502020204030204" pitchFamily="34" charset="0"/>
                </a:rPr>
                <a:t>m</a:t>
              </a:r>
              <a:r>
                <a:rPr lang="en-US" altLang="ko-KR" sz="1000" b="1" dirty="0">
                  <a:latin typeface="Calibri" panose="020F0502020204030204" pitchFamily="34" charset="0"/>
                  <a:cs typeface="Calibri" panose="020F0502020204030204" pitchFamily="34" charset="0"/>
                </a:rPr>
                <a:t>g/ml)</a:t>
              </a:r>
              <a:endParaRPr lang="ko-KR" altLang="en-US" sz="1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aphicFrame>
          <p:nvGraphicFramePr>
            <p:cNvPr id="22" name="개체 21">
              <a:extLst>
                <a:ext uri="{FF2B5EF4-FFF2-40B4-BE49-F238E27FC236}">
                  <a16:creationId xmlns:a16="http://schemas.microsoft.com/office/drawing/2014/main" id="{B603D3E1-033D-4EC1-BF1A-0607C6194063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2372695" y="4602435"/>
            <a:ext cx="1922462" cy="1604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45" name="Prism 6" r:id="rId6" imgW="3442680" imgH="2642400" progId="Prism6.Document">
                    <p:embed/>
                  </p:oleObj>
                </mc:Choice>
                <mc:Fallback>
                  <p:oleObj name="Prism 6" r:id="rId6" imgW="3442680" imgH="2642400" progId="Prism6.Document">
                    <p:embed/>
                    <p:pic>
                      <p:nvPicPr>
                        <p:cNvPr id="22" name="개체 21">
                          <a:extLst>
                            <a:ext uri="{FF2B5EF4-FFF2-40B4-BE49-F238E27FC236}">
                              <a16:creationId xmlns:a16="http://schemas.microsoft.com/office/drawing/2014/main" id="{B603D3E1-033D-4EC1-BF1A-0607C61940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372695" y="4602435"/>
                          <a:ext cx="1922462" cy="1604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6" name="오른쪽 대괄호 15">
            <a:extLst>
              <a:ext uri="{FF2B5EF4-FFF2-40B4-BE49-F238E27FC236}">
                <a16:creationId xmlns:a16="http://schemas.microsoft.com/office/drawing/2014/main" id="{3ABE6A3C-62FA-4C14-B1CE-6C40F8CACE77}"/>
              </a:ext>
            </a:extLst>
          </p:cNvPr>
          <p:cNvSpPr/>
          <p:nvPr/>
        </p:nvSpPr>
        <p:spPr>
          <a:xfrm rot="16200000">
            <a:off x="1460772" y="4645884"/>
            <a:ext cx="45721" cy="43711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FEC4ACA-C741-4539-9C13-4E6CAD35EFD3}"/>
              </a:ext>
            </a:extLst>
          </p:cNvPr>
          <p:cNvSpPr txBox="1"/>
          <p:nvPr/>
        </p:nvSpPr>
        <p:spPr>
          <a:xfrm>
            <a:off x="1173155" y="4625975"/>
            <a:ext cx="6156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i="1" dirty="0"/>
              <a:t>p</a:t>
            </a:r>
            <a:r>
              <a:rPr lang="ko-KR" altLang="en-US" sz="900" dirty="0"/>
              <a:t> </a:t>
            </a:r>
            <a:r>
              <a:rPr lang="en-US" altLang="ko-KR" sz="900" dirty="0"/>
              <a:t>=</a:t>
            </a:r>
            <a:r>
              <a:rPr lang="ko-KR" altLang="en-US" sz="900" dirty="0"/>
              <a:t> </a:t>
            </a:r>
            <a:r>
              <a:rPr lang="en-US" altLang="ko-KR" sz="900" dirty="0"/>
              <a:t>0.893</a:t>
            </a:r>
            <a:endParaRPr lang="ko-KR" altLang="en-US" sz="900" dirty="0"/>
          </a:p>
        </p:txBody>
      </p:sp>
      <p:sp>
        <p:nvSpPr>
          <p:cNvPr id="18" name="오른쪽 대괄호 17">
            <a:extLst>
              <a:ext uri="{FF2B5EF4-FFF2-40B4-BE49-F238E27FC236}">
                <a16:creationId xmlns:a16="http://schemas.microsoft.com/office/drawing/2014/main" id="{BF4D5B68-8A63-4429-9761-1A6BA0E84DD7}"/>
              </a:ext>
            </a:extLst>
          </p:cNvPr>
          <p:cNvSpPr/>
          <p:nvPr/>
        </p:nvSpPr>
        <p:spPr>
          <a:xfrm rot="16200000">
            <a:off x="3270917" y="4599189"/>
            <a:ext cx="45721" cy="43711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33A3CAA-36E5-433B-80ED-A13FCF833CA3}"/>
              </a:ext>
            </a:extLst>
          </p:cNvPr>
          <p:cNvSpPr txBox="1"/>
          <p:nvPr/>
        </p:nvSpPr>
        <p:spPr>
          <a:xfrm>
            <a:off x="2983300" y="4579280"/>
            <a:ext cx="6156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i="1" dirty="0"/>
              <a:t>p</a:t>
            </a:r>
            <a:r>
              <a:rPr lang="ko-KR" altLang="en-US" sz="900" dirty="0"/>
              <a:t> </a:t>
            </a:r>
            <a:r>
              <a:rPr lang="en-US" altLang="ko-KR" sz="900" dirty="0"/>
              <a:t>=</a:t>
            </a:r>
            <a:r>
              <a:rPr lang="ko-KR" altLang="en-US" sz="900" dirty="0"/>
              <a:t> </a:t>
            </a:r>
            <a:r>
              <a:rPr lang="en-US" altLang="ko-KR" sz="900" dirty="0"/>
              <a:t>0.899</a:t>
            </a:r>
            <a:endParaRPr lang="ko-KR" altLang="en-US" sz="9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6B64E16-9BF3-4020-9201-D82D7644C463}"/>
              </a:ext>
            </a:extLst>
          </p:cNvPr>
          <p:cNvSpPr txBox="1"/>
          <p:nvPr/>
        </p:nvSpPr>
        <p:spPr>
          <a:xfrm>
            <a:off x="316269" y="1133931"/>
            <a:ext cx="59819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Table 2. Periodontal parameters of non-RA and RA subjects with slight periodontitis</a:t>
            </a:r>
            <a:endParaRPr lang="ko-KR" altLang="en-US" sz="12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25ECD0F-4B03-452A-8196-48958EB8B244}"/>
              </a:ext>
            </a:extLst>
          </p:cNvPr>
          <p:cNvSpPr txBox="1"/>
          <p:nvPr/>
        </p:nvSpPr>
        <p:spPr>
          <a:xfrm>
            <a:off x="370212" y="6515522"/>
            <a:ext cx="61175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Figure 2. </a:t>
            </a:r>
            <a:r>
              <a:rPr lang="en-US" altLang="ko-KR" sz="1200" dirty="0"/>
              <a:t>(A) Concentrations of anti-TdEno and anti-ENO1 IgG antibodies in sera from non-RA subjects with slight periodontitis (n = 50) shown in Figure 2A were compared with those of RA subjects with slight periodontitis (n = 38). (B) Spearman’s correlation between the levels of anti-TdEno and anti-ENO1 antibodies is shown. </a:t>
            </a:r>
            <a:endParaRPr lang="ko-KR" altLang="en-US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F78D54-5841-4010-B142-90DA16BC3296}"/>
              </a:ext>
            </a:extLst>
          </p:cNvPr>
          <p:cNvSpPr txBox="1"/>
          <p:nvPr/>
        </p:nvSpPr>
        <p:spPr>
          <a:xfrm>
            <a:off x="935629" y="6024600"/>
            <a:ext cx="545342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900" dirty="0"/>
              <a:t>Non-RA</a:t>
            </a:r>
            <a:endParaRPr lang="ko-KR" altLang="en-US" sz="9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AB6E079-3C1C-4D9E-8C79-6D8DBF0C0299}"/>
              </a:ext>
            </a:extLst>
          </p:cNvPr>
          <p:cNvSpPr txBox="1"/>
          <p:nvPr/>
        </p:nvSpPr>
        <p:spPr>
          <a:xfrm>
            <a:off x="2730279" y="6024600"/>
            <a:ext cx="545342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900" dirty="0"/>
              <a:t>Non-RA</a:t>
            </a:r>
            <a:endParaRPr lang="ko-KR" altLang="en-US" sz="9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CC82730-106F-4627-B654-403CB66B7ADF}"/>
              </a:ext>
            </a:extLst>
          </p:cNvPr>
          <p:cNvSpPr txBox="1"/>
          <p:nvPr/>
        </p:nvSpPr>
        <p:spPr>
          <a:xfrm>
            <a:off x="1746430" y="6024600"/>
            <a:ext cx="314510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900" dirty="0"/>
              <a:t>RA</a:t>
            </a:r>
            <a:endParaRPr lang="ko-KR" altLang="en-US" sz="9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CE90610-D1EE-4FA2-A3AB-E9742F1E2D0F}"/>
              </a:ext>
            </a:extLst>
          </p:cNvPr>
          <p:cNvSpPr txBox="1"/>
          <p:nvPr/>
        </p:nvSpPr>
        <p:spPr>
          <a:xfrm>
            <a:off x="3531166" y="6024600"/>
            <a:ext cx="314510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900" dirty="0"/>
              <a:t>RA</a:t>
            </a:r>
            <a:endParaRPr lang="ko-KR" altLang="en-US" sz="900" dirty="0"/>
          </a:p>
        </p:txBody>
      </p:sp>
    </p:spTree>
    <p:extLst>
      <p:ext uri="{BB962C8B-B14F-4D97-AF65-F5344CB8AC3E}">
        <p14:creationId xmlns:p14="http://schemas.microsoft.com/office/powerpoint/2010/main" val="2763188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7</Words>
  <Application>Microsoft Office PowerPoint</Application>
  <PresentationFormat>A4 용지(210x297mm)</PresentationFormat>
  <Paragraphs>108</Paragraphs>
  <Slides>2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rism 6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.</dc:title>
  <dc:creator>win7</dc:creator>
  <cp:lastModifiedBy>최영님</cp:lastModifiedBy>
  <cp:revision>195</cp:revision>
  <cp:lastPrinted>2018-04-15T19:24:57Z</cp:lastPrinted>
  <dcterms:created xsi:type="dcterms:W3CDTF">2017-03-14T03:59:26Z</dcterms:created>
  <dcterms:modified xsi:type="dcterms:W3CDTF">2018-06-21T05:04:06Z</dcterms:modified>
</cp:coreProperties>
</file>